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notesMasterIdLst>
    <p:notesMasterId r:id="rId1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398" autoAdjust="0"/>
    <p:restoredTop sz="82329" autoAdjust="0"/>
  </p:normalViewPr>
  <p:slideViewPr>
    <p:cSldViewPr snapToGrid="0">
      <p:cViewPr varScale="1">
        <p:scale>
          <a:sx n="99" d="100"/>
          <a:sy n="99" d="100"/>
        </p:scale>
        <p:origin x="752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>
      <p:cViewPr>
        <p:scale>
          <a:sx n="210" d="100"/>
          <a:sy n="210" d="100"/>
        </p:scale>
        <p:origin x="1232" y="-3456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0BF6E2F-CFCC-49E2-8778-32CCB6B20EE3}" type="datetimeFigureOut">
              <a:rPr lang="en-US" smtClean="0"/>
              <a:t>4/25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099FC3-4B27-4EBB-8EB5-8764B4CF44A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00325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68443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758825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SIRS=Systemic Inflammatory Response Syndrome </a:t>
            </a:r>
          </a:p>
          <a:p>
            <a:r>
              <a:rPr lang="en-US" dirty="0" err="1"/>
              <a:t>qSOFA</a:t>
            </a:r>
            <a:r>
              <a:rPr lang="en-US" dirty="0"/>
              <a:t>=quick Sequential Organ Failure Assessment </a:t>
            </a:r>
          </a:p>
          <a:p>
            <a:r>
              <a:rPr lang="en-US" dirty="0"/>
              <a:t>Recommended labs are CBC, CMP, lipase, VBG, lactate, coag, urinalysis, blood cultures, and chest XR.  Consider additional studies based on patient presentation and complaint and DIC  panel if indicated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898738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46113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Necrotizing fasciitis can have pain out of proportion, pain outside the margin, and sepsis without a clear source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158637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nion gap calculated 130.6+3.5-94-12 = 24.6</a:t>
            </a:r>
          </a:p>
          <a:p>
            <a:r>
              <a:rPr lang="en-US" dirty="0"/>
              <a:t>Corrected sodium = serum sodium + </a:t>
            </a:r>
            <a:r>
              <a:rPr lang="en-US"/>
              <a:t>1.6*(</a:t>
            </a:r>
            <a:r>
              <a:rPr lang="en-US" dirty="0"/>
              <a:t>serum </a:t>
            </a:r>
            <a:r>
              <a:rPr lang="en-US"/>
              <a:t>glucose-100/1000)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88349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IVF should initially be run at 1L/hr, or open if hypotensive. Change to rate of 1.5 maintenance or 150 ml/hr OR urine output at 50 ml/hr.</a:t>
            </a:r>
          </a:p>
          <a:p>
            <a:r>
              <a:rPr lang="en-US" dirty="0"/>
              <a:t>No difference using lactated ringers and NS initially for resuscitation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648077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ADA recommended 100 mmol of NaHCO3 in 400ml H2O + 20 mEq KDL and infuse for 2 hours; repeat q2hr until pH &gt;or equal to 7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008056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Without surgical treatment, mortality is almost 100%.</a:t>
            </a:r>
          </a:p>
          <a:p>
            <a:r>
              <a:rPr lang="en-US" dirty="0"/>
              <a:t>Clindamycin has antitoxic effects for beta hemolytic </a:t>
            </a:r>
            <a:r>
              <a:rPr lang="en-US" i="1" dirty="0"/>
              <a:t>strep</a:t>
            </a:r>
            <a:r>
              <a:rPr lang="en-US" dirty="0"/>
              <a:t> and </a:t>
            </a:r>
            <a:r>
              <a:rPr lang="en-US" i="1" dirty="0"/>
              <a:t>S. aureus</a:t>
            </a:r>
            <a:r>
              <a:rPr lang="en-US" dirty="0"/>
              <a:t>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771625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099FC3-4B27-4EBB-8EB5-8764B4CF44AC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79650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DF1A20C-7D64-1A1C-3A13-8E5CD336C70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1079CA-7380-3225-8DA8-E114D0376E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562E93-90F6-BE3A-6A20-F6CD393CC2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2FD3CF0-3D7F-5A5C-8C08-1CC5C1584B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9A30F5-EA07-1CA9-5CA3-A6D7F2608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782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664C5F-0F20-B977-C772-3CDB68CD6F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B81FB13-9AF2-022B-1101-CB523FCA3B6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3A7EC-E922-9B36-CCBB-17489D7CF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72F16C-1BF2-EBA8-1F9F-AA61F5B06C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EFD5E3-A274-98CC-49BE-DDF811C625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920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9EFEDD2-5D75-D453-4F83-F6E903FBDAF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C956387-C267-8227-6C3C-E75937353A7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19C60-C256-23AF-A907-35E910668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70E0B1-385E-709F-9464-99DBD5AE6A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F30724-8CEF-8369-ADA3-4D7FE624C8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63246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151D5F-ADA1-33D4-87B2-57F91D9FD77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48F3C8-72EC-1D8E-5A9F-4478155E317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12C74B-EDB0-1546-9797-784E30A8E5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4FDEE-A24A-8D4F-822D-581FE973CC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01276B-FE59-EFD7-411D-E145413919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7451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98A2D4-FE9F-D996-878E-7B299F144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C2620D0-552C-B32C-05D1-E200C2591F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28940F-6DD0-3293-4080-6000A11793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0753BC-A3B8-3467-C1F8-205F9668C9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7F119B-7968-500E-70EB-61223D69DC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3289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5F4E3D-F0C1-88F8-6287-C5EA967F0E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93516D3-2899-03F6-0034-F5BD0C58E2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96B43A2-0DDF-0E26-04B2-9567BEECF3A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7E64B3A-5833-5D87-89B6-4FF0AA4341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D57780-11AF-3980-7E13-E949A9F3A3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67C731-0A82-9E7E-4A37-BC26749ED2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0071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75A3C2-0B00-29A0-F8A7-C7875E91EE4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940B4F-10A4-B1F6-5898-711212BB97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85FE2F2-9288-2AB5-594E-6CCF8FEFD6A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0E1DCFF-1CCB-19DA-39C2-400C6771715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34A0B96-061A-0296-2B02-342C863BEC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09AF043-09C4-3101-B420-FF3355AF5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796A5ED-BC2E-5EE2-BE91-E4D795FD13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3C16F51-BA64-F67E-D2A7-7CE0CB8D56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035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8A347A-402B-5FA6-1535-C1137D0941A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B3174A-1C4C-9EAD-12AF-FF0FE500DD3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1C5213B-12DE-BB1E-E60C-94D0E6D9D9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822E231-6AA4-2B42-D355-655FEB0DC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909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0BF99DD-4D7B-F7AD-E4FA-C3231A7412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802555F-0499-FA76-3448-7E5541B25A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4D99550-E914-958C-91A1-EE003497EE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4269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30E36A-A67A-6E70-47FF-AC63F059C9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0363100-D508-A123-217E-B510F88EA5E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9C22A4C-C02D-3B8C-D280-1EA93B1C4D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D4B575-F541-3208-ADBC-DCE949D26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D70569-6EA0-5F21-EB4A-7BBFF0655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933BCF6-11AF-F92D-23E3-377F4415C1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010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E8F9B1-7A88-CA67-6BD7-30BA448598B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584EB94-CA81-626F-7256-B39B8FB1E01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1F568B3-01F6-442C-E2AB-0392064481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1E718EC-1801-A01F-5A60-FAABEC5F06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BAB943-B3EE-5C43-ACD6-DBBF20BD63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A631E17-668A-DD4A-FCAE-1A1167E734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6546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EB47A6-3DCB-4BBA-4266-3DC516DEA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E5AEBD4-42B1-173B-ACB5-FF3274B351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EE81BCB-5F52-C9AD-E863-2D858917C9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E9EFDD-0114-4FB0-8469-801425A0410F}" type="datetimeFigureOut">
              <a:rPr lang="en-US" smtClean="0"/>
              <a:t>4/25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C316A6-4A19-F828-0CDF-1E541B32D0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DF1DC2-2AE3-383A-108E-99FD653E85C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7FBAFB-0EBC-47DF-A486-13801FE010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00927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s://radiopaedia.org/cases/anaerobic-cellulitis?lang=us" TargetMode="Externa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25E50D-BBCF-000B-A940-3487E3A94BA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000250" y="1122363"/>
            <a:ext cx="8191500" cy="2306637"/>
          </a:xfrm>
        </p:spPr>
        <p:txBody>
          <a:bodyPr>
            <a:normAutofit fontScale="90000"/>
          </a:bodyPr>
          <a:lstStyle/>
          <a:p>
            <a:r>
              <a:rPr lang="en-US" dirty="0"/>
              <a:t>DKA and Necrotizing Soft Tissue Infection</a:t>
            </a:r>
            <a:br>
              <a:rPr lang="en-US" dirty="0"/>
            </a:br>
            <a:r>
              <a:rPr lang="en-US" dirty="0"/>
              <a:t>Small Group Cas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6DFB1F3-84C6-D9A7-0CE9-E30C6C8486F0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Debriefing And Education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9CBCB47E-EEF7-7A94-35AB-6431A809F6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542398" y="6212829"/>
            <a:ext cx="1422400" cy="482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8607925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D578B8-0784-3314-7F8A-E65F4290A0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ritical Action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774F67F-CD75-BE67-91F7-CB97A2C3B9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rders BMP &amp; VBG (data acquisition, systems-based practice)</a:t>
            </a:r>
          </a:p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Hydrates patient in response to dehydration (problem solving, patient care)</a:t>
            </a:r>
          </a:p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Start Insulin drip (problem solving, patient care)</a:t>
            </a:r>
          </a:p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Orders &amp; interprets x-ray right foot (data acquisition, problem solving, systems-based practice)</a:t>
            </a:r>
          </a:p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dministers appropriate antibiotics (patient care)  </a:t>
            </a:r>
          </a:p>
          <a:p>
            <a:r>
              <a:rPr lang="en-US" sz="2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Consults ortho or podiatry for immediate surgery (problem solving, patient care, clinical competence)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029923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72463A-D400-8FA8-B391-7B48899646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40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Diabetic Ketoacidosis (DKA)</a:t>
            </a:r>
            <a:endParaRPr lang="en-US" sz="80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704503-FA4B-F630-A487-3ED7C4B5212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Point of care (POC) glucose reads “high”</a:t>
            </a:r>
          </a:p>
          <a:p>
            <a:r>
              <a:rPr lang="en-US" dirty="0"/>
              <a:t>Consider:</a:t>
            </a:r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  <a:p>
            <a:r>
              <a:rPr lang="en-US" dirty="0"/>
              <a:t>Lab Orders:</a:t>
            </a:r>
          </a:p>
          <a:p>
            <a:pPr lvl="1"/>
            <a:endParaRPr lang="en-US" dirty="0"/>
          </a:p>
        </p:txBody>
      </p:sp>
      <p:graphicFrame>
        <p:nvGraphicFramePr>
          <p:cNvPr id="6" name="Table 6">
            <a:extLst>
              <a:ext uri="{FF2B5EF4-FFF2-40B4-BE49-F238E27FC236}">
                <a16:creationId xmlns:a16="http://schemas.microsoft.com/office/drawing/2014/main" id="{413C24D7-428F-C068-852C-8AB9FD3CC28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77741730"/>
              </p:ext>
            </p:extLst>
          </p:nvPr>
        </p:nvGraphicFramePr>
        <p:xfrm>
          <a:off x="1758868" y="2990374"/>
          <a:ext cx="8127999" cy="138176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3164579740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760104830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4161035764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Nonketotic hyperglycemia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yperosmolar hyperglycemic state (HHS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DKA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56753418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ep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emochromato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Iron Toxicity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3961966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Myocardial infar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Pancreatit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Toxic alcoho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52743830"/>
                  </a:ext>
                </a:extLst>
              </a:tr>
            </a:tbl>
          </a:graphicData>
        </a:graphic>
      </p:graphicFrame>
      <p:graphicFrame>
        <p:nvGraphicFramePr>
          <p:cNvPr id="7" name="Table 7">
            <a:extLst>
              <a:ext uri="{FF2B5EF4-FFF2-40B4-BE49-F238E27FC236}">
                <a16:creationId xmlns:a16="http://schemas.microsoft.com/office/drawing/2014/main" id="{6812EAD4-5760-6116-A0FB-342CB560432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82443989"/>
              </p:ext>
            </p:extLst>
          </p:nvPr>
        </p:nvGraphicFramePr>
        <p:xfrm>
          <a:off x="1758868" y="5213157"/>
          <a:ext cx="8127999" cy="73660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2709333">
                  <a:extLst>
                    <a:ext uri="{9D8B030D-6E8A-4147-A177-3AD203B41FA5}">
                      <a16:colId xmlns:a16="http://schemas.microsoft.com/office/drawing/2014/main" val="2247045866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84623677"/>
                    </a:ext>
                  </a:extLst>
                </a:gridCol>
                <a:gridCol w="2709333">
                  <a:extLst>
                    <a:ext uri="{9D8B030D-6E8A-4147-A177-3AD203B41FA5}">
                      <a16:colId xmlns:a16="http://schemas.microsoft.com/office/drawing/2014/main" val="199601622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r>
                        <a:rPr lang="en-US" dirty="0"/>
                        <a:t>Venous blood gas (VBG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Metabolic Pane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Beta-hydroxybutyrate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57296137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Serum Osmolality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Urinalysi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Lactate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792995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8910524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0ACE66-DDCA-DDD8-F379-412E7167BDD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epsis &amp; SIRS Criteri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F9FB502-84B4-35B3-22D3-EEB2EF4A072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960562"/>
            <a:ext cx="10515600" cy="4667250"/>
          </a:xfrm>
        </p:spPr>
        <p:txBody>
          <a:bodyPr>
            <a:normAutofit/>
          </a:bodyPr>
          <a:lstStyle/>
          <a:p>
            <a:r>
              <a:rPr lang="en-US" dirty="0"/>
              <a:t>SIRS: ≥2 or more of the following:</a:t>
            </a:r>
          </a:p>
          <a:p>
            <a:endParaRPr lang="en-US" dirty="0"/>
          </a:p>
          <a:p>
            <a:endParaRPr lang="en-US" dirty="0"/>
          </a:p>
          <a:p>
            <a:endParaRPr lang="en-US" dirty="0"/>
          </a:p>
          <a:p>
            <a:r>
              <a:rPr lang="en-US" dirty="0" err="1"/>
              <a:t>qSOFA</a:t>
            </a:r>
            <a:r>
              <a:rPr lang="en-US" dirty="0"/>
              <a:t> ≥2; 1 point each</a:t>
            </a:r>
          </a:p>
          <a:p>
            <a:endParaRPr lang="en-US" dirty="0"/>
          </a:p>
          <a:p>
            <a:pPr lvl="1"/>
            <a:r>
              <a:rPr lang="en-US" dirty="0"/>
              <a:t>Criteria for risk stratification, but not diagnostic</a:t>
            </a:r>
          </a:p>
          <a:p>
            <a:r>
              <a:rPr lang="en-US" dirty="0"/>
              <a:t>Blood cultures, appropriate fluids bolus, early antibiotics, appropriate labs &amp; imaging, and vasopressors if MAP ≤65</a:t>
            </a:r>
          </a:p>
          <a:p>
            <a:endParaRPr lang="en-US" dirty="0"/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BF48E1CE-8192-A81F-F4A6-847FC96EB0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1435686"/>
              </p:ext>
            </p:extLst>
          </p:nvPr>
        </p:nvGraphicFramePr>
        <p:xfrm>
          <a:off x="1509484" y="2441589"/>
          <a:ext cx="8869550" cy="7416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4083794">
                  <a:extLst>
                    <a:ext uri="{9D8B030D-6E8A-4147-A177-3AD203B41FA5}">
                      <a16:colId xmlns:a16="http://schemas.microsoft.com/office/drawing/2014/main" val="3011913671"/>
                    </a:ext>
                  </a:extLst>
                </a:gridCol>
                <a:gridCol w="4785756">
                  <a:extLst>
                    <a:ext uri="{9D8B030D-6E8A-4147-A177-3AD203B41FA5}">
                      <a16:colId xmlns:a16="http://schemas.microsoft.com/office/drawing/2014/main" val="1028615948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Temperature &gt;38°C or &lt;36°C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HR &gt;90 BPM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398448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RR &gt;20breaths/min or PaCO2 &lt;32mmHg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WBC &gt;12,000/mm</a:t>
                      </a:r>
                      <a:r>
                        <a:rPr lang="en-US" sz="1800" baseline="30000" dirty="0"/>
                        <a:t>3</a:t>
                      </a:r>
                      <a:r>
                        <a:rPr lang="en-US" dirty="0"/>
                        <a:t>, &lt;4000/mm</a:t>
                      </a:r>
                      <a:r>
                        <a:rPr lang="en-US" baseline="30000" dirty="0"/>
                        <a:t>3</a:t>
                      </a:r>
                      <a:r>
                        <a:rPr lang="en-US" dirty="0"/>
                        <a:t>, or &gt;10% band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25583401"/>
                  </a:ext>
                </a:extLst>
              </a:tr>
            </a:tbl>
          </a:graphicData>
        </a:graphic>
      </p:graphicFrame>
      <p:graphicFrame>
        <p:nvGraphicFramePr>
          <p:cNvPr id="5" name="Table 5">
            <a:extLst>
              <a:ext uri="{FF2B5EF4-FFF2-40B4-BE49-F238E27FC236}">
                <a16:creationId xmlns:a16="http://schemas.microsoft.com/office/drawing/2014/main" id="{EF804737-3401-0D65-F0F7-04044CF7BE0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3775348"/>
              </p:ext>
            </p:extLst>
          </p:nvPr>
        </p:nvGraphicFramePr>
        <p:xfrm>
          <a:off x="1509483" y="4395079"/>
          <a:ext cx="8869551" cy="37084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2706256">
                  <a:extLst>
                    <a:ext uri="{9D8B030D-6E8A-4147-A177-3AD203B41FA5}">
                      <a16:colId xmlns:a16="http://schemas.microsoft.com/office/drawing/2014/main" val="3866606908"/>
                    </a:ext>
                  </a:extLst>
                </a:gridCol>
                <a:gridCol w="3206778">
                  <a:extLst>
                    <a:ext uri="{9D8B030D-6E8A-4147-A177-3AD203B41FA5}">
                      <a16:colId xmlns:a16="http://schemas.microsoft.com/office/drawing/2014/main" val="384976852"/>
                    </a:ext>
                  </a:extLst>
                </a:gridCol>
                <a:gridCol w="2956517">
                  <a:extLst>
                    <a:ext uri="{9D8B030D-6E8A-4147-A177-3AD203B41FA5}">
                      <a16:colId xmlns:a16="http://schemas.microsoft.com/office/drawing/2014/main" val="465760125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r>
                        <a:rPr lang="en-US" dirty="0"/>
                        <a:t>&lt;SBP 10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Altered mental status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RR ≥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67222162"/>
                  </a:ext>
                </a:extLst>
              </a:tr>
            </a:tbl>
          </a:graphicData>
        </a:graphic>
      </p:graphicFrame>
      <p:sp>
        <p:nvSpPr>
          <p:cNvPr id="6" name="Octagon 5">
            <a:extLst>
              <a:ext uri="{FF2B5EF4-FFF2-40B4-BE49-F238E27FC236}">
                <a16:creationId xmlns:a16="http://schemas.microsoft.com/office/drawing/2014/main" id="{2C48507D-CE88-9CDD-D534-D8A7ABBAB377}"/>
              </a:ext>
            </a:extLst>
          </p:cNvPr>
          <p:cNvSpPr/>
          <p:nvPr/>
        </p:nvSpPr>
        <p:spPr>
          <a:xfrm>
            <a:off x="7744264" y="5832669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</p:spTree>
    <p:extLst>
      <p:ext uri="{BB962C8B-B14F-4D97-AF65-F5344CB8AC3E}">
        <p14:creationId xmlns:p14="http://schemas.microsoft.com/office/powerpoint/2010/main" val="37598426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346F63-7D42-BDD0-25B3-9D71E71AFB1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hest X-Ray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92781E8B-F52C-41A4-ECB3-EC617D0CC9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38200" y="1435306"/>
            <a:ext cx="5486400" cy="443865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Image preview">
            <a:extLst>
              <a:ext uri="{FF2B5EF4-FFF2-40B4-BE49-F238E27FC236}">
                <a16:creationId xmlns:a16="http://schemas.microsoft.com/office/drawing/2014/main" id="{640D2D78-DBF8-D2B0-CD40-D2B4A9B8EB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69531" y="480788"/>
            <a:ext cx="4467687" cy="545446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DFB6D79-0BF1-24D0-C39B-40AC7AEF2681}"/>
              </a:ext>
            </a:extLst>
          </p:cNvPr>
          <p:cNvSpPr txBox="1"/>
          <p:nvPr/>
        </p:nvSpPr>
        <p:spPr>
          <a:xfrm>
            <a:off x="1043940" y="6156960"/>
            <a:ext cx="832104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Normal chest XR – No obvious source of infection</a:t>
            </a:r>
          </a:p>
        </p:txBody>
      </p:sp>
    </p:spTree>
    <p:extLst>
      <p:ext uri="{BB962C8B-B14F-4D97-AF65-F5344CB8AC3E}">
        <p14:creationId xmlns:p14="http://schemas.microsoft.com/office/powerpoint/2010/main" val="73673461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0C9A2-9583-6339-FD4C-DD5CC3BF290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Foot X-Ray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2AC5F074-3FCA-CF2E-A676-7011CE2D1B6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874227" y="1156503"/>
            <a:ext cx="6343650" cy="505777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5" name="Straight Arrow Connector 4">
            <a:extLst>
              <a:ext uri="{FF2B5EF4-FFF2-40B4-BE49-F238E27FC236}">
                <a16:creationId xmlns:a16="http://schemas.microsoft.com/office/drawing/2014/main" id="{E53F1DB1-474C-3825-F0F1-A53AE5132D41}"/>
              </a:ext>
            </a:extLst>
          </p:cNvPr>
          <p:cNvCxnSpPr/>
          <p:nvPr/>
        </p:nvCxnSpPr>
        <p:spPr>
          <a:xfrm flipH="1" flipV="1">
            <a:off x="8121936" y="4476124"/>
            <a:ext cx="490818" cy="806824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sp>
        <p:nvSpPr>
          <p:cNvPr id="6" name="Octagon 5">
            <a:extLst>
              <a:ext uri="{FF2B5EF4-FFF2-40B4-BE49-F238E27FC236}">
                <a16:creationId xmlns:a16="http://schemas.microsoft.com/office/drawing/2014/main" id="{20E0047F-F747-36D0-40EB-5FBD5B4B0297}"/>
              </a:ext>
            </a:extLst>
          </p:cNvPr>
          <p:cNvSpPr/>
          <p:nvPr/>
        </p:nvSpPr>
        <p:spPr>
          <a:xfrm>
            <a:off x="8827476" y="5042950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1C05E93-F3BE-63BC-DAED-EC2461AC718C}"/>
              </a:ext>
            </a:extLst>
          </p:cNvPr>
          <p:cNvSpPr txBox="1"/>
          <p:nvPr/>
        </p:nvSpPr>
        <p:spPr>
          <a:xfrm>
            <a:off x="1174652" y="6372665"/>
            <a:ext cx="993179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Dr Henry Knipe Anaerobic cellulitis In Radiopaedia.org </a:t>
            </a:r>
            <a:r>
              <a:rPr lang="en-US" sz="1000" b="1" u="sng" dirty="0">
                <a:solidFill>
                  <a:srgbClr val="0563C1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hlinkClick r:id="rId4"/>
              </a:rPr>
              <a:t>https://radiopaedia.org/cases/anaerobic-cellulitis?lang=us</a:t>
            </a:r>
            <a:r>
              <a:rPr lang="en-US" sz="10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C BY-NC-SA 3.0.</a:t>
            </a:r>
          </a:p>
          <a:p>
            <a:endParaRPr lang="en-US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F5162B7-9F5C-6010-7492-8337E3953F93}"/>
              </a:ext>
            </a:extLst>
          </p:cNvPr>
          <p:cNvSpPr txBox="1"/>
          <p:nvPr/>
        </p:nvSpPr>
        <p:spPr>
          <a:xfrm>
            <a:off x="441960" y="2644170"/>
            <a:ext cx="327660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400" dirty="0"/>
              <a:t>Free air in soft tissue. With exam findings, suspect as source of infection</a:t>
            </a:r>
          </a:p>
        </p:txBody>
      </p:sp>
    </p:spTree>
    <p:extLst>
      <p:ext uri="{BB962C8B-B14F-4D97-AF65-F5344CB8AC3E}">
        <p14:creationId xmlns:p14="http://schemas.microsoft.com/office/powerpoint/2010/main" val="272591297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A26B86-CA61-BA66-C8F8-69CA3EBF56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KA Diagnosi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7B5CD9-822A-A2D9-A75C-337E967F62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2216627"/>
            <a:ext cx="10515600" cy="4351338"/>
          </a:xfrm>
        </p:spPr>
        <p:txBody>
          <a:bodyPr/>
          <a:lstStyle/>
          <a:p>
            <a:endParaRPr lang="en-US" dirty="0"/>
          </a:p>
          <a:p>
            <a:r>
              <a:rPr lang="en-US" dirty="0"/>
              <a:t>Anion Gap  24.6 mEq/L</a:t>
            </a:r>
          </a:p>
          <a:p>
            <a:r>
              <a:rPr lang="en-US" dirty="0"/>
              <a:t>Corrected Sodium 143 mEq/L</a:t>
            </a:r>
          </a:p>
          <a:p>
            <a:r>
              <a:rPr lang="en-US" dirty="0"/>
              <a:t>Hyperglycemia (&gt;200 mg/dL), Acidosis (pH &lt;7.3), and ketonemia</a:t>
            </a:r>
          </a:p>
          <a:p>
            <a:r>
              <a:rPr lang="en-US" dirty="0"/>
              <a:t>SGLT-2 Inhibitors can have euglycemia DKA</a:t>
            </a:r>
          </a:p>
          <a:p>
            <a:r>
              <a:rPr lang="en-US" dirty="0"/>
              <a:t>Ketonuria may have a false negative in DKA</a:t>
            </a:r>
          </a:p>
          <a:p>
            <a:r>
              <a:rPr lang="en-US" dirty="0"/>
              <a:t>Consider ETCO2 with glucose 550 mg/dL</a:t>
            </a:r>
          </a:p>
          <a:p>
            <a:pPr lvl="1"/>
            <a:r>
              <a:rPr lang="en-US" dirty="0"/>
              <a:t>≥35 100% sensitive to rule out ≤21 100% specific to rule in DKA</a:t>
            </a:r>
          </a:p>
        </p:txBody>
      </p:sp>
      <p:graphicFrame>
        <p:nvGraphicFramePr>
          <p:cNvPr id="4" name="Table 4">
            <a:extLst>
              <a:ext uri="{FF2B5EF4-FFF2-40B4-BE49-F238E27FC236}">
                <a16:creationId xmlns:a16="http://schemas.microsoft.com/office/drawing/2014/main" id="{417D2EFA-D917-9A35-1101-D55165B119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86753587"/>
              </p:ext>
            </p:extLst>
          </p:nvPr>
        </p:nvGraphicFramePr>
        <p:xfrm>
          <a:off x="838200" y="1825625"/>
          <a:ext cx="10207171" cy="640080"/>
        </p:xfrm>
        <a:graphic>
          <a:graphicData uri="http://schemas.openxmlformats.org/drawingml/2006/table">
            <a:tbl>
              <a:tblPr bandRow="1">
                <a:tableStyleId>{5C22544A-7EE6-4342-B048-85BDC9FD1C3A}</a:tableStyleId>
              </a:tblPr>
              <a:tblGrid>
                <a:gridCol w="1383693">
                  <a:extLst>
                    <a:ext uri="{9D8B030D-6E8A-4147-A177-3AD203B41FA5}">
                      <a16:colId xmlns:a16="http://schemas.microsoft.com/office/drawing/2014/main" val="2328208950"/>
                    </a:ext>
                  </a:extLst>
                </a:gridCol>
                <a:gridCol w="883830">
                  <a:extLst>
                    <a:ext uri="{9D8B030D-6E8A-4147-A177-3AD203B41FA5}">
                      <a16:colId xmlns:a16="http://schemas.microsoft.com/office/drawing/2014/main" val="999641425"/>
                    </a:ext>
                  </a:extLst>
                </a:gridCol>
                <a:gridCol w="867903">
                  <a:extLst>
                    <a:ext uri="{9D8B030D-6E8A-4147-A177-3AD203B41FA5}">
                      <a16:colId xmlns:a16="http://schemas.microsoft.com/office/drawing/2014/main" val="3016175402"/>
                    </a:ext>
                  </a:extLst>
                </a:gridCol>
                <a:gridCol w="1875631">
                  <a:extLst>
                    <a:ext uri="{9D8B030D-6E8A-4147-A177-3AD203B41FA5}">
                      <a16:colId xmlns:a16="http://schemas.microsoft.com/office/drawing/2014/main" val="2550837778"/>
                    </a:ext>
                  </a:extLst>
                </a:gridCol>
                <a:gridCol w="2307772">
                  <a:extLst>
                    <a:ext uri="{9D8B030D-6E8A-4147-A177-3AD203B41FA5}">
                      <a16:colId xmlns:a16="http://schemas.microsoft.com/office/drawing/2014/main" val="3146582343"/>
                    </a:ext>
                  </a:extLst>
                </a:gridCol>
                <a:gridCol w="2888342">
                  <a:extLst>
                    <a:ext uri="{9D8B030D-6E8A-4147-A177-3AD203B41FA5}">
                      <a16:colId xmlns:a16="http://schemas.microsoft.com/office/drawing/2014/main" val="4057971068"/>
                    </a:ext>
                  </a:extLst>
                </a:gridCol>
              </a:tblGrid>
              <a:tr h="472250">
                <a:tc>
                  <a:txBody>
                    <a:bodyPr/>
                    <a:lstStyle/>
                    <a:p>
                      <a:r>
                        <a:rPr lang="en-US" dirty="0"/>
                        <a:t>Na 130.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K 3.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l 94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CO2 12 mmol/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Glucose 862 mg/dL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dirty="0"/>
                        <a:t>    Beta Hydroxybutyrate 3 mEq/L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870581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9914136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1EA373-6AA0-09AD-F7C5-F6C97E1DB3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KA Treat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0DCD56-590D-369B-9D7C-3778048E9DB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4"/>
            <a:ext cx="10515600" cy="4533611"/>
          </a:xfrm>
        </p:spPr>
        <p:txBody>
          <a:bodyPr>
            <a:normAutofit/>
          </a:bodyPr>
          <a:lstStyle/>
          <a:p>
            <a:r>
              <a:rPr lang="en-US" dirty="0"/>
              <a:t>Patients are often dehydrated</a:t>
            </a:r>
          </a:p>
          <a:p>
            <a:pPr lvl="1"/>
            <a:r>
              <a:rPr lang="en-US" dirty="0"/>
              <a:t>Initial treatment of 20 ml/kg up to 50 ml/kg (in the first 4 hours) ideal body weight of isotonic crystalloids</a:t>
            </a:r>
          </a:p>
          <a:p>
            <a:pPr lvl="1"/>
            <a:r>
              <a:rPr lang="en-US" dirty="0"/>
              <a:t>Consider ½ NS based on dehydration status, corrected sodium, and potassium levels when the labs return</a:t>
            </a:r>
          </a:p>
          <a:p>
            <a:r>
              <a:rPr lang="en-US" dirty="0"/>
              <a:t>Patients often have low body potassium and magnesium as the serum acid drives potassium out of the cells</a:t>
            </a:r>
          </a:p>
          <a:p>
            <a:pPr lvl="1"/>
            <a:r>
              <a:rPr lang="en-US" dirty="0"/>
              <a:t>K ≤3.3 use ½ NS 20-40 mEq KCl</a:t>
            </a:r>
          </a:p>
          <a:p>
            <a:pPr lvl="1"/>
            <a:r>
              <a:rPr lang="en-US" dirty="0"/>
              <a:t>K 3.5-5.3 use ½ NS 20-30 mEq KCl</a:t>
            </a:r>
          </a:p>
          <a:p>
            <a:pPr lvl="1"/>
            <a:r>
              <a:rPr lang="en-US" dirty="0"/>
              <a:t>K ≥5.3 no supplemental KCl</a:t>
            </a:r>
          </a:p>
          <a:p>
            <a:r>
              <a:rPr lang="en-US" dirty="0"/>
              <a:t>Replenish magnesium and phosphorus as needed</a:t>
            </a:r>
          </a:p>
        </p:txBody>
      </p:sp>
      <p:sp>
        <p:nvSpPr>
          <p:cNvPr id="4" name="Octagon 3">
            <a:extLst>
              <a:ext uri="{FF2B5EF4-FFF2-40B4-BE49-F238E27FC236}">
                <a16:creationId xmlns:a16="http://schemas.microsoft.com/office/drawing/2014/main" id="{A4387A5C-D7DA-CC5C-543C-1374D7054FEC}"/>
              </a:ext>
            </a:extLst>
          </p:cNvPr>
          <p:cNvSpPr/>
          <p:nvPr/>
        </p:nvSpPr>
        <p:spPr>
          <a:xfrm>
            <a:off x="10942319" y="2123904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</p:spTree>
    <p:extLst>
      <p:ext uri="{BB962C8B-B14F-4D97-AF65-F5344CB8AC3E}">
        <p14:creationId xmlns:p14="http://schemas.microsoft.com/office/powerpoint/2010/main" val="143088556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BA314F-7AD3-8C30-7AA0-DA7C27A22D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KA Treatment (cont.)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FDBFBD7-384D-3906-1E73-FCD57CFCA2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US" dirty="0"/>
              <a:t>Initial insulin bolus of 0.1 units/kg is deemed unnecessary by some sources</a:t>
            </a:r>
          </a:p>
          <a:p>
            <a:r>
              <a:rPr lang="en-US" dirty="0"/>
              <a:t>Start short-acting insulin at 0.1 unit/kg/hr</a:t>
            </a:r>
          </a:p>
          <a:p>
            <a:pPr lvl="1"/>
            <a:r>
              <a:rPr lang="en-US" dirty="0"/>
              <a:t>Maintain glucose between 150-200 mg/dL</a:t>
            </a:r>
          </a:p>
          <a:p>
            <a:pPr lvl="1"/>
            <a:r>
              <a:rPr lang="en-US" dirty="0"/>
              <a:t>If blood glucose &lt;250 mg/dL consider half insulin infusion rate or switch to D5 or D10 versus D50 bolus if the blood glucose &lt;150 mg/dL</a:t>
            </a:r>
          </a:p>
          <a:p>
            <a:r>
              <a:rPr lang="en-US" dirty="0"/>
              <a:t>Goal is resolution of acidosis</a:t>
            </a:r>
          </a:p>
          <a:p>
            <a:r>
              <a:rPr lang="en-US" dirty="0"/>
              <a:t>If the pH &lt;6.9, give bicarbonate</a:t>
            </a:r>
          </a:p>
        </p:txBody>
      </p:sp>
      <p:sp>
        <p:nvSpPr>
          <p:cNvPr id="5" name="Octagon 4">
            <a:extLst>
              <a:ext uri="{FF2B5EF4-FFF2-40B4-BE49-F238E27FC236}">
                <a16:creationId xmlns:a16="http://schemas.microsoft.com/office/drawing/2014/main" id="{4C257F63-A38F-4B54-DDB0-3B44F61B0B1C}"/>
              </a:ext>
            </a:extLst>
          </p:cNvPr>
          <p:cNvSpPr/>
          <p:nvPr/>
        </p:nvSpPr>
        <p:spPr>
          <a:xfrm>
            <a:off x="7730196" y="2745765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</p:spTree>
    <p:extLst>
      <p:ext uri="{BB962C8B-B14F-4D97-AF65-F5344CB8AC3E}">
        <p14:creationId xmlns:p14="http://schemas.microsoft.com/office/powerpoint/2010/main" val="2980531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4A4ADA-1A08-2B03-39F1-CE2A916A2D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oft Tissue Necrotizing Infection Treatment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C6330E-5185-0852-D1E2-6E7F13FD8FC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9783493" cy="4351338"/>
          </a:xfrm>
        </p:spPr>
        <p:txBody>
          <a:bodyPr/>
          <a:lstStyle/>
          <a:p>
            <a:r>
              <a:rPr lang="en-US" dirty="0"/>
              <a:t>Surgical exploration and debridement is definitive treatment and should not be delayed</a:t>
            </a:r>
          </a:p>
          <a:p>
            <a:r>
              <a:rPr lang="en-US" dirty="0"/>
              <a:t>Broad spectrum antibiotics</a:t>
            </a:r>
          </a:p>
          <a:p>
            <a:pPr lvl="1"/>
            <a:r>
              <a:rPr lang="en-US" dirty="0"/>
              <a:t>Vancomycin or linezolid PLUS piperacillin-tazobactam or carbapenem PLUS clindamycin</a:t>
            </a:r>
          </a:p>
        </p:txBody>
      </p:sp>
      <p:sp>
        <p:nvSpPr>
          <p:cNvPr id="4" name="Octagon 3">
            <a:extLst>
              <a:ext uri="{FF2B5EF4-FFF2-40B4-BE49-F238E27FC236}">
                <a16:creationId xmlns:a16="http://schemas.microsoft.com/office/drawing/2014/main" id="{873AF5AD-A2E4-FA1E-C7FF-B5D0715122F6}"/>
              </a:ext>
            </a:extLst>
          </p:cNvPr>
          <p:cNvSpPr/>
          <p:nvPr/>
        </p:nvSpPr>
        <p:spPr>
          <a:xfrm>
            <a:off x="10712547" y="1690688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  <p:sp>
        <p:nvSpPr>
          <p:cNvPr id="5" name="Octagon 4">
            <a:extLst>
              <a:ext uri="{FF2B5EF4-FFF2-40B4-BE49-F238E27FC236}">
                <a16:creationId xmlns:a16="http://schemas.microsoft.com/office/drawing/2014/main" id="{716DF159-B381-3ED9-0D2D-C5D33F790AE8}"/>
              </a:ext>
            </a:extLst>
          </p:cNvPr>
          <p:cNvSpPr/>
          <p:nvPr/>
        </p:nvSpPr>
        <p:spPr>
          <a:xfrm>
            <a:off x="10385473" y="3166719"/>
            <a:ext cx="822961" cy="795143"/>
          </a:xfrm>
          <a:prstGeom prst="octagon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100" dirty="0"/>
              <a:t>Critical Action</a:t>
            </a:r>
          </a:p>
        </p:txBody>
      </p:sp>
    </p:spTree>
    <p:extLst>
      <p:ext uri="{BB962C8B-B14F-4D97-AF65-F5344CB8AC3E}">
        <p14:creationId xmlns:p14="http://schemas.microsoft.com/office/powerpoint/2010/main" val="36599332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98</Words>
  <Application>Microsoft Macintosh PowerPoint</Application>
  <PresentationFormat>Widescreen</PresentationFormat>
  <Paragraphs>113</Paragraphs>
  <Slides>10</Slides>
  <Notes>9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5" baseType="lpstr">
      <vt:lpstr>Arial</vt:lpstr>
      <vt:lpstr>Calibri</vt:lpstr>
      <vt:lpstr>Calibri Light</vt:lpstr>
      <vt:lpstr>Times New Roman</vt:lpstr>
      <vt:lpstr>Office Theme</vt:lpstr>
      <vt:lpstr>DKA and Necrotizing Soft Tissue Infection Small Group Case</vt:lpstr>
      <vt:lpstr>Diabetic Ketoacidosis (DKA)</vt:lpstr>
      <vt:lpstr>Sepsis &amp; SIRS Criteria</vt:lpstr>
      <vt:lpstr>Chest X-Ray</vt:lpstr>
      <vt:lpstr>Foot X-Ray</vt:lpstr>
      <vt:lpstr>DKA Diagnosis</vt:lpstr>
      <vt:lpstr>DKA Treatment</vt:lpstr>
      <vt:lpstr>DKA Treatment (cont.)</vt:lpstr>
      <vt:lpstr>Soft Tissue Necrotizing Infection Treatment</vt:lpstr>
      <vt:lpstr>Critical Action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/>
  <cp:lastModifiedBy/>
  <cp:revision>1</cp:revision>
  <dcterms:created xsi:type="dcterms:W3CDTF">2023-04-12T16:12:44Z</dcterms:created>
  <dcterms:modified xsi:type="dcterms:W3CDTF">2025-04-25T20:28:15Z</dcterms:modified>
</cp:coreProperties>
</file>